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sldIdLst>
    <p:sldId id="259" r:id="rId3"/>
  </p:sldIdLst>
  <p:sldSz cx="6858000" cy="9906000" type="A4"/>
  <p:notesSz cx="6858000" cy="9144000"/>
  <p:defaultTextStyle>
    <a:defPPr>
      <a:defRPr lang="en-US"/>
    </a:defPPr>
    <a:lvl1pPr marL="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7117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423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135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847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5588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270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982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694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8000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197DD02-14E5-4F5E-9C2D-1F2A44CBF196}" v="2" dt="2022-02-07T17:58:31.02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310" d="100"/>
          <a:sy n="310" d="100"/>
        </p:scale>
        <p:origin x="-3930" y="-116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5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4" indent="0" algn="ctr">
              <a:buNone/>
              <a:defRPr sz="1500"/>
            </a:lvl2pPr>
            <a:lvl3pPr marL="685787" indent="0" algn="ctr">
              <a:buNone/>
              <a:defRPr sz="1350"/>
            </a:lvl3pPr>
            <a:lvl4pPr marL="1028681" indent="0" algn="ctr">
              <a:buNone/>
              <a:defRPr sz="1200"/>
            </a:lvl4pPr>
            <a:lvl5pPr marL="1371575" indent="0" algn="ctr">
              <a:buNone/>
              <a:defRPr sz="1200"/>
            </a:lvl5pPr>
            <a:lvl6pPr marL="1714468" indent="0" algn="ctr">
              <a:buNone/>
              <a:defRPr sz="1200"/>
            </a:lvl6pPr>
            <a:lvl7pPr marL="2057362" indent="0" algn="ctr">
              <a:buNone/>
              <a:defRPr sz="1200"/>
            </a:lvl7pPr>
            <a:lvl8pPr marL="2400256" indent="0" algn="ctr">
              <a:buNone/>
              <a:defRPr sz="1200"/>
            </a:lvl8pPr>
            <a:lvl9pPr marL="274315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093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083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3202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09772-E514-45B9-8CF4-92DF4A6135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0B107E-D851-4A12-AF94-3795778259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ED4F1-9F3A-456F-80DC-5DED50F7B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43F402-3486-4322-8248-4BAC83098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52FD9-FD18-4157-9687-A8A4A14A4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0741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1DA3B-973B-4351-A78A-50D6F2F52E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4C3936-2E45-47F5-88F3-CC0FBE8D54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13BC8E-2B2C-4037-83EA-D6DE8A5C7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4022F1-9174-4AA9-9B99-052261590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E1F1A-C3FB-42B5-96B2-AA7DDB520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36190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AF10E-E890-48B5-B9DA-7DB62C863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8AC4CF-EB1B-4163-AB69-524FAC55FA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6CEA9-E99A-48A1-9606-17174C455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866BD5-BB1E-4126-A0A8-E3E1A846B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A13870-8824-49E0-9A21-3BF5A1F6B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96786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B2F9F-6256-443A-9A23-B42146D66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E53B4-9221-49A7-A6E7-FCCEF6836A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6838"/>
            <a:ext cx="2881312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9B7275-D924-43C6-A4C7-66B557518B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505200" y="2636838"/>
            <a:ext cx="2881313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BD0C1F-73DC-43E9-B48D-D786852B7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95FBBF-74A2-4E6B-BC75-1E37657A2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C51576-CC48-498E-8765-DE56DAE5A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26433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03F30-C803-47E4-8347-5E6023980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BA377A-880F-4EC6-97FF-CAEBE1C583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6F3534-8A8F-4D28-B44D-79D31C57D8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E94583-C1AF-41D9-9033-6050FDE773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DEE9E9-1F08-4E9A-A20D-A5DF3777F6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C1012B-0494-4A31-8816-3C5926416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1BBDD3-2A6F-4A19-8A39-887DDC085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8116A3-8B03-4714-8830-66560B948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4749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628F8-CF4E-488A-93AF-1BC5118B8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4E3929-5A95-436D-B902-CE72CF6B2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BAB1B8-0FA4-41DE-BD94-D5A883C13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25A80C-9A52-4647-A2A9-6F6FB9C3A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8155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E630A6-7184-47A2-9972-68A98471D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C77312-F2DE-4132-9397-D14795928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B088FC-332A-4E9A-9CD0-BB20FAD2E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81809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8BCF8-8542-4164-8762-60C12241F7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38C008-472E-4C2E-A842-76D1B9F721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83FB18-C304-4CC4-9A13-ED8C38F16B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1B6FC1-91E3-4769-A0B1-C0DCC4B70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6C68DB-9C40-4AE0-96F4-82A16DC4E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5ABE2B-7320-4B70-8DF1-4A75C7DFA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34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40801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E560F-FBA5-4A57-BAAB-B5B245AF6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06DF3D-976B-41C0-8413-E44AB34432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99E36D-E537-456F-A46E-D956F8FA29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EBEAB-7AD1-4AC6-8783-9A3BFDD6F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D40531-89C0-454E-A9D7-6412C7CC6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B01019-E7CE-47CA-92FF-7434AF3B2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7353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23F2D-2D6D-4BF4-96F3-A38D85AA6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284063-D278-4428-A223-48C303113D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9DE4D9-9DFD-4B19-9A4B-F4A9711AF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F7B78-D83E-482B-8423-D48D005E9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AAD84-DF58-4E58-B84B-940D4E858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854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FD37CB-620B-4C5A-886D-763C2B493C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8550" y="527050"/>
            <a:ext cx="1477963" cy="83947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BB42B9-5DBB-4588-803A-5E31F1002E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527050"/>
            <a:ext cx="4284662" cy="83947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8DE5B-9C7F-4C6C-88C6-A7DE08E4A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ABC10-CB61-4AD4-A91B-39588FE54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5FAA9-D874-44EA-9C94-8FF9115EC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23901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9165A-EB3D-4DE9-956A-6302BF273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D5DFB-FAC6-419C-B452-9ED84B38F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69401A-86BB-478E-8EE9-747E0FDF4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C80AC-60F4-4902-9B12-604D07091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129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7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6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5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635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7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13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86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091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93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4" indent="0">
              <a:buNone/>
              <a:defRPr sz="2100"/>
            </a:lvl2pPr>
            <a:lvl3pPr marL="685787" indent="0">
              <a:buNone/>
              <a:defRPr sz="1800"/>
            </a:lvl3pPr>
            <a:lvl4pPr marL="1028681" indent="0">
              <a:buNone/>
              <a:defRPr sz="1500"/>
            </a:lvl4pPr>
            <a:lvl5pPr marL="1371575" indent="0">
              <a:buNone/>
              <a:defRPr sz="1500"/>
            </a:lvl5pPr>
            <a:lvl6pPr marL="1714468" indent="0">
              <a:buNone/>
              <a:defRPr sz="1500"/>
            </a:lvl6pPr>
            <a:lvl7pPr marL="2057362" indent="0">
              <a:buNone/>
              <a:defRPr sz="1500"/>
            </a:lvl7pPr>
            <a:lvl8pPr marL="2400256" indent="0">
              <a:buNone/>
              <a:defRPr sz="1500"/>
            </a:lvl8pPr>
            <a:lvl9pPr marL="274315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63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50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7" indent="-171447" algn="l" defTabSz="68578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41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34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8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22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15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09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03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97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4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7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81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75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68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62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56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5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FEA7FF-5392-453F-B97E-628C7A069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00A679-CADD-47AC-953E-FE520426F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79E62A-4952-4FF1-8805-218D387117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94C13-E29D-41AC-93DC-B46213509B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FB7D7B-27F5-48A9-AB98-28A54E3D8A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709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1687F51D-B7FC-4C4C-8ACC-5CEA8C41A32C}"/>
              </a:ext>
            </a:extLst>
          </p:cNvPr>
          <p:cNvSpPr txBox="1"/>
          <p:nvPr/>
        </p:nvSpPr>
        <p:spPr>
          <a:xfrm>
            <a:off x="0" y="-29165"/>
            <a:ext cx="4782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0DA76B6-1A0A-4985-845E-BA8B70D5FE30}"/>
              </a:ext>
            </a:extLst>
          </p:cNvPr>
          <p:cNvGrpSpPr/>
          <p:nvPr/>
        </p:nvGrpSpPr>
        <p:grpSpPr>
          <a:xfrm>
            <a:off x="95021" y="494055"/>
            <a:ext cx="6667957" cy="7784355"/>
            <a:chOff x="92904" y="816366"/>
            <a:chExt cx="6667957" cy="7784355"/>
          </a:xfrm>
        </p:grpSpPr>
        <p:pic>
          <p:nvPicPr>
            <p:cNvPr id="212" name="Picture 211" descr="A picture containing text, night sky&#10;&#10;Description automatically generated">
              <a:extLst>
                <a:ext uri="{FF2B5EF4-FFF2-40B4-BE49-F238E27FC236}">
                  <a16:creationId xmlns:a16="http://schemas.microsoft.com/office/drawing/2014/main" id="{571EA514-56F2-47FB-A5C1-26CFAEC9F2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0238" y="6185253"/>
              <a:ext cx="3220623" cy="2415468"/>
            </a:xfrm>
            <a:prstGeom prst="rect">
              <a:avLst/>
            </a:prstGeom>
          </p:spPr>
        </p:pic>
        <p:pic>
          <p:nvPicPr>
            <p:cNvPr id="210" name="Picture 209" descr="A screen with text on it&#10;&#10;Description automatically generated with low confidence">
              <a:extLst>
                <a:ext uri="{FF2B5EF4-FFF2-40B4-BE49-F238E27FC236}">
                  <a16:creationId xmlns:a16="http://schemas.microsoft.com/office/drawing/2014/main" id="{97F988DA-3A19-4A21-A84E-486B6420833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904" y="6182076"/>
              <a:ext cx="3224860" cy="2418645"/>
            </a:xfrm>
            <a:prstGeom prst="rect">
              <a:avLst/>
            </a:prstGeom>
          </p:spPr>
        </p:pic>
        <p:pic>
          <p:nvPicPr>
            <p:cNvPr id="208" name="Picture 207" descr="A picture containing text, night sky&#10;&#10;Description automatically generated">
              <a:extLst>
                <a:ext uri="{FF2B5EF4-FFF2-40B4-BE49-F238E27FC236}">
                  <a16:creationId xmlns:a16="http://schemas.microsoft.com/office/drawing/2014/main" id="{6E813051-5500-46A6-A8DD-231E0EBA754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0600" y="3486889"/>
              <a:ext cx="3217407" cy="2413055"/>
            </a:xfrm>
            <a:prstGeom prst="rect">
              <a:avLst/>
            </a:prstGeom>
          </p:spPr>
        </p:pic>
        <p:pic>
          <p:nvPicPr>
            <p:cNvPr id="206" name="Picture 205" descr="A screen with text on it&#10;&#10;Description automatically generated with low confidence">
              <a:extLst>
                <a:ext uri="{FF2B5EF4-FFF2-40B4-BE49-F238E27FC236}">
                  <a16:creationId xmlns:a16="http://schemas.microsoft.com/office/drawing/2014/main" id="{75BCBA95-74FE-4156-A33A-80BA2EBF920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009" y="3482662"/>
              <a:ext cx="3235375" cy="2426532"/>
            </a:xfrm>
            <a:prstGeom prst="rect">
              <a:avLst/>
            </a:prstGeom>
          </p:spPr>
        </p:pic>
        <p:pic>
          <p:nvPicPr>
            <p:cNvPr id="204" name="Picture 203" descr="A screen with text on it&#10;&#10;Description automatically generated with low confidence">
              <a:extLst>
                <a:ext uri="{FF2B5EF4-FFF2-40B4-BE49-F238E27FC236}">
                  <a16:creationId xmlns:a16="http://schemas.microsoft.com/office/drawing/2014/main" id="{08773688-4F7B-4834-ADA6-B30A7956FDB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2011" y="826281"/>
              <a:ext cx="3211402" cy="2408552"/>
            </a:xfrm>
            <a:prstGeom prst="rect">
              <a:avLst/>
            </a:prstGeom>
          </p:spPr>
        </p:pic>
        <p:pic>
          <p:nvPicPr>
            <p:cNvPr id="202" name="Picture 201" descr="A picture containing text, black, dark, night sky&#10;&#10;Description automatically generated">
              <a:extLst>
                <a:ext uri="{FF2B5EF4-FFF2-40B4-BE49-F238E27FC236}">
                  <a16:creationId xmlns:a16="http://schemas.microsoft.com/office/drawing/2014/main" id="{69622B6A-C5E3-4E36-B707-882485B349C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614" y="832450"/>
              <a:ext cx="3211402" cy="2408551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676CF3A-2891-4E52-83BE-B6EEA6045416}"/>
                </a:ext>
              </a:extLst>
            </p:cNvPr>
            <p:cNvSpPr txBox="1"/>
            <p:nvPr/>
          </p:nvSpPr>
          <p:spPr>
            <a:xfrm>
              <a:off x="109994" y="816366"/>
              <a:ext cx="424543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0023763-7DD3-48F3-91EC-A2734EF5D990}"/>
                </a:ext>
              </a:extLst>
            </p:cNvPr>
            <p:cNvSpPr txBox="1"/>
            <p:nvPr/>
          </p:nvSpPr>
          <p:spPr>
            <a:xfrm>
              <a:off x="3566879" y="816366"/>
              <a:ext cx="424543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0214513-9315-4801-82B2-2C1F37587816}"/>
                </a:ext>
              </a:extLst>
            </p:cNvPr>
            <p:cNvSpPr txBox="1"/>
            <p:nvPr/>
          </p:nvSpPr>
          <p:spPr>
            <a:xfrm>
              <a:off x="109993" y="3436058"/>
              <a:ext cx="424543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F420830-617F-4C7E-AD06-A82922B8B693}"/>
                </a:ext>
              </a:extLst>
            </p:cNvPr>
            <p:cNvSpPr txBox="1"/>
            <p:nvPr/>
          </p:nvSpPr>
          <p:spPr>
            <a:xfrm>
              <a:off x="3562107" y="3436055"/>
              <a:ext cx="424543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F7F4AF0-28CC-4CFF-9DDF-BD6B7F85B71A}"/>
                </a:ext>
              </a:extLst>
            </p:cNvPr>
            <p:cNvSpPr txBox="1"/>
            <p:nvPr/>
          </p:nvSpPr>
          <p:spPr>
            <a:xfrm>
              <a:off x="109993" y="6309750"/>
              <a:ext cx="424543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5AAD4EF-5116-4829-A841-7970FCD874E7}"/>
                </a:ext>
              </a:extLst>
            </p:cNvPr>
            <p:cNvSpPr txBox="1"/>
            <p:nvPr/>
          </p:nvSpPr>
          <p:spPr>
            <a:xfrm>
              <a:off x="3562106" y="6321228"/>
              <a:ext cx="424543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FD8150C8-47E8-4748-B10C-461C6D7044FD}"/>
                </a:ext>
              </a:extLst>
            </p:cNvPr>
            <p:cNvGrpSpPr/>
            <p:nvPr/>
          </p:nvGrpSpPr>
          <p:grpSpPr>
            <a:xfrm>
              <a:off x="939917" y="1602502"/>
              <a:ext cx="715283" cy="203342"/>
              <a:chOff x="2146336" y="-636596"/>
              <a:chExt cx="2055589" cy="203342"/>
            </a:xfrm>
          </p:grpSpPr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60A5C177-CBDD-4461-B336-B4D39D710F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3254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C5107564-68B6-4076-85E2-9B517F5971A1}"/>
                  </a:ext>
                </a:extLst>
              </p:cNvPr>
              <p:cNvSpPr txBox="1"/>
              <p:nvPr/>
            </p:nvSpPr>
            <p:spPr>
              <a:xfrm>
                <a:off x="2350561" y="-636596"/>
                <a:ext cx="1641938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stine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6263603-AB32-4388-83DB-EC6277634C5B}"/>
                </a:ext>
              </a:extLst>
            </p:cNvPr>
            <p:cNvSpPr txBox="1"/>
            <p:nvPr/>
          </p:nvSpPr>
          <p:spPr>
            <a:xfrm>
              <a:off x="865145" y="1811580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F3F96DC-C787-45DB-8D70-7979F75CF0E5}"/>
                </a:ext>
              </a:extLst>
            </p:cNvPr>
            <p:cNvSpPr txBox="1"/>
            <p:nvPr/>
          </p:nvSpPr>
          <p:spPr>
            <a:xfrm>
              <a:off x="964782" y="1811580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i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0F44D0B-ADA4-4B51-8D16-87AB988045A9}"/>
                </a:ext>
              </a:extLst>
            </p:cNvPr>
            <p:cNvSpPr txBox="1"/>
            <p:nvPr/>
          </p:nvSpPr>
          <p:spPr>
            <a:xfrm>
              <a:off x="1080607" y="1811580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i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C1F14C4-385A-4EA5-BA93-F06EB0A4D372}"/>
                </a:ext>
              </a:extLst>
            </p:cNvPr>
            <p:cNvSpPr txBox="1"/>
            <p:nvPr/>
          </p:nvSpPr>
          <p:spPr>
            <a:xfrm>
              <a:off x="1165994" y="1813037"/>
              <a:ext cx="279109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i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89901E9-3092-4CA5-9655-58A870AE996A}"/>
                </a:ext>
              </a:extLst>
            </p:cNvPr>
            <p:cNvSpPr txBox="1"/>
            <p:nvPr/>
          </p:nvSpPr>
          <p:spPr>
            <a:xfrm>
              <a:off x="1291582" y="1813054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i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1300A21-F424-4544-B187-99CF15C71287}"/>
                </a:ext>
              </a:extLst>
            </p:cNvPr>
            <p:cNvSpPr txBox="1"/>
            <p:nvPr/>
          </p:nvSpPr>
          <p:spPr>
            <a:xfrm>
              <a:off x="1398958" y="1813054"/>
              <a:ext cx="243240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i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355C6EA-217A-4FE7-A5D9-D9E068C72DAF}"/>
                </a:ext>
              </a:extLst>
            </p:cNvPr>
            <p:cNvSpPr txBox="1"/>
            <p:nvPr/>
          </p:nvSpPr>
          <p:spPr>
            <a:xfrm>
              <a:off x="1489758" y="1813427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1D5A467-688B-4FEC-AA2D-461E4BB80373}"/>
                </a:ext>
              </a:extLst>
            </p:cNvPr>
            <p:cNvSpPr txBox="1"/>
            <p:nvPr/>
          </p:nvSpPr>
          <p:spPr>
            <a:xfrm>
              <a:off x="1603565" y="1813132"/>
              <a:ext cx="26849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</a:t>
              </a:r>
              <a:endPara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F541A02-6DBC-43C3-ACCF-CD214B216094}"/>
                </a:ext>
              </a:extLst>
            </p:cNvPr>
            <p:cNvSpPr txBox="1"/>
            <p:nvPr/>
          </p:nvSpPr>
          <p:spPr>
            <a:xfrm>
              <a:off x="2259468" y="1811578"/>
              <a:ext cx="271842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8918347-4B6A-48DC-962A-02D6CAA58599}"/>
                </a:ext>
              </a:extLst>
            </p:cNvPr>
            <p:cNvSpPr txBox="1"/>
            <p:nvPr/>
          </p:nvSpPr>
          <p:spPr>
            <a:xfrm>
              <a:off x="1703154" y="1811969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98BB6E0-9004-4BCD-95DD-77F86D161B31}"/>
                </a:ext>
              </a:extLst>
            </p:cNvPr>
            <p:cNvSpPr txBox="1"/>
            <p:nvPr/>
          </p:nvSpPr>
          <p:spPr>
            <a:xfrm>
              <a:off x="1816142" y="1810940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b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DDC16E2-634F-4360-9DBB-36A930B5E76E}"/>
                </a:ext>
              </a:extLst>
            </p:cNvPr>
            <p:cNvSpPr txBox="1"/>
            <p:nvPr/>
          </p:nvSpPr>
          <p:spPr>
            <a:xfrm>
              <a:off x="1922249" y="1812206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b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E864758-764C-48E6-BC5F-B32545D2566F}"/>
                </a:ext>
              </a:extLst>
            </p:cNvPr>
            <p:cNvSpPr txBox="1"/>
            <p:nvPr/>
          </p:nvSpPr>
          <p:spPr>
            <a:xfrm>
              <a:off x="2154401" y="1811954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b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97D32A5-4617-4639-9BD6-0867D8A474E4}"/>
                </a:ext>
              </a:extLst>
            </p:cNvPr>
            <p:cNvSpPr txBox="1"/>
            <p:nvPr/>
          </p:nvSpPr>
          <p:spPr>
            <a:xfrm>
              <a:off x="761291" y="1815968"/>
              <a:ext cx="22492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BBA6679-5860-4714-BF97-20BC1B16AC1F}"/>
                </a:ext>
              </a:extLst>
            </p:cNvPr>
            <p:cNvSpPr txBox="1"/>
            <p:nvPr/>
          </p:nvSpPr>
          <p:spPr>
            <a:xfrm>
              <a:off x="2045958" y="1810940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b</a:t>
              </a:r>
            </a:p>
          </p:txBody>
        </p: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9428FD01-2985-4330-A45B-62A7C4D78D0A}"/>
                </a:ext>
              </a:extLst>
            </p:cNvPr>
            <p:cNvGrpSpPr/>
            <p:nvPr/>
          </p:nvGrpSpPr>
          <p:grpSpPr>
            <a:xfrm>
              <a:off x="1618352" y="1603959"/>
              <a:ext cx="925308" cy="200506"/>
              <a:chOff x="1880149" y="-630829"/>
              <a:chExt cx="2659161" cy="200506"/>
            </a:xfrm>
          </p:grpSpPr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168B0644-1FFF-4413-936A-FEB554B19F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0323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99A68137-5B09-49A1-B3D5-2F59477DF462}"/>
                  </a:ext>
                </a:extLst>
              </p:cNvPr>
              <p:cNvSpPr txBox="1"/>
              <p:nvPr/>
            </p:nvSpPr>
            <p:spPr>
              <a:xfrm>
                <a:off x="1880149" y="-630829"/>
                <a:ext cx="2659161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scle bag region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7DD0AC5-F315-43A3-9811-56E0127F1CFA}"/>
                </a:ext>
              </a:extLst>
            </p:cNvPr>
            <p:cNvSpPr txBox="1"/>
            <p:nvPr/>
          </p:nvSpPr>
          <p:spPr>
            <a:xfrm>
              <a:off x="465030" y="2389306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219BC6D-4695-473A-A542-F7925ED822AE}"/>
                </a:ext>
              </a:extLst>
            </p:cNvPr>
            <p:cNvSpPr txBox="1"/>
            <p:nvPr/>
          </p:nvSpPr>
          <p:spPr>
            <a:xfrm>
              <a:off x="466966" y="2185654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9D9D4D1-C9F4-47A5-AF10-ED71D2F7AB4C}"/>
                </a:ext>
              </a:extLst>
            </p:cNvPr>
            <p:cNvSpPr txBox="1"/>
            <p:nvPr/>
          </p:nvSpPr>
          <p:spPr>
            <a:xfrm>
              <a:off x="464082" y="2074505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50bp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4C324AC-90A8-4E69-998B-2B875E941D8B}"/>
                </a:ext>
              </a:extLst>
            </p:cNvPr>
            <p:cNvSpPr txBox="1"/>
            <p:nvPr/>
          </p:nvSpPr>
          <p:spPr>
            <a:xfrm>
              <a:off x="485569" y="2001816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AF6B360-D888-485C-807F-F9F1129D9E25}"/>
                </a:ext>
              </a:extLst>
            </p:cNvPr>
            <p:cNvSpPr txBox="1"/>
            <p:nvPr/>
          </p:nvSpPr>
          <p:spPr>
            <a:xfrm>
              <a:off x="485568" y="1961840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80883864-C7FE-4456-8353-B335BE996DF4}"/>
                </a:ext>
              </a:extLst>
            </p:cNvPr>
            <p:cNvGrpSpPr/>
            <p:nvPr/>
          </p:nvGrpSpPr>
          <p:grpSpPr>
            <a:xfrm>
              <a:off x="4321727" y="1482381"/>
              <a:ext cx="715283" cy="203342"/>
              <a:chOff x="2146336" y="-636596"/>
              <a:chExt cx="2055589" cy="203342"/>
            </a:xfrm>
          </p:grpSpPr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2624CF0B-C42C-4F74-B410-7020188C9B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3254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654155E9-9B04-4505-9CF9-1FFBCF675F4A}"/>
                  </a:ext>
                </a:extLst>
              </p:cNvPr>
              <p:cNvSpPr txBox="1"/>
              <p:nvPr/>
            </p:nvSpPr>
            <p:spPr>
              <a:xfrm>
                <a:off x="2350561" y="-636596"/>
                <a:ext cx="1641938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stine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D7FA354-5172-4063-93BD-E1988778A999}"/>
                </a:ext>
              </a:extLst>
            </p:cNvPr>
            <p:cNvSpPr txBox="1"/>
            <p:nvPr/>
          </p:nvSpPr>
          <p:spPr>
            <a:xfrm>
              <a:off x="4246955" y="1691459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F8449E0-0EC7-425A-B4B2-6A1C9715DB93}"/>
                </a:ext>
              </a:extLst>
            </p:cNvPr>
            <p:cNvSpPr txBox="1"/>
            <p:nvPr/>
          </p:nvSpPr>
          <p:spPr>
            <a:xfrm>
              <a:off x="4346592" y="1691459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i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40A55AD-F0A7-43E8-B480-52AA5C3760FD}"/>
                </a:ext>
              </a:extLst>
            </p:cNvPr>
            <p:cNvSpPr txBox="1"/>
            <p:nvPr/>
          </p:nvSpPr>
          <p:spPr>
            <a:xfrm>
              <a:off x="4462417" y="1691459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i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81874E2-3C8D-4832-8047-D3AE53414973}"/>
                </a:ext>
              </a:extLst>
            </p:cNvPr>
            <p:cNvSpPr txBox="1"/>
            <p:nvPr/>
          </p:nvSpPr>
          <p:spPr>
            <a:xfrm>
              <a:off x="4547804" y="1692916"/>
              <a:ext cx="279109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i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6743FF9-8528-4F66-A22B-C607C41ECAD0}"/>
                </a:ext>
              </a:extLst>
            </p:cNvPr>
            <p:cNvSpPr txBox="1"/>
            <p:nvPr/>
          </p:nvSpPr>
          <p:spPr>
            <a:xfrm>
              <a:off x="4673392" y="1692933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i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2892052-C3E5-410D-9D64-2940AF3712CA}"/>
                </a:ext>
              </a:extLst>
            </p:cNvPr>
            <p:cNvSpPr txBox="1"/>
            <p:nvPr/>
          </p:nvSpPr>
          <p:spPr>
            <a:xfrm>
              <a:off x="4780768" y="1692933"/>
              <a:ext cx="243240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i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E6368AD-6F74-4130-BB82-C37BD717DFA1}"/>
                </a:ext>
              </a:extLst>
            </p:cNvPr>
            <p:cNvSpPr txBox="1"/>
            <p:nvPr/>
          </p:nvSpPr>
          <p:spPr>
            <a:xfrm>
              <a:off x="4871568" y="1693306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902875FE-E2A8-40E0-B5FB-B0A9AB548710}"/>
                </a:ext>
              </a:extLst>
            </p:cNvPr>
            <p:cNvSpPr txBox="1"/>
            <p:nvPr/>
          </p:nvSpPr>
          <p:spPr>
            <a:xfrm>
              <a:off x="4985375" y="1693011"/>
              <a:ext cx="26849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</a:t>
              </a:r>
              <a:endPara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97E3282-D40C-4616-9054-A9D2AD13BAEA}"/>
                </a:ext>
              </a:extLst>
            </p:cNvPr>
            <p:cNvSpPr txBox="1"/>
            <p:nvPr/>
          </p:nvSpPr>
          <p:spPr>
            <a:xfrm>
              <a:off x="5641278" y="1691457"/>
              <a:ext cx="271842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341AEEA-A32D-4B4C-A1F6-ACDB1347A67B}"/>
                </a:ext>
              </a:extLst>
            </p:cNvPr>
            <p:cNvSpPr txBox="1"/>
            <p:nvPr/>
          </p:nvSpPr>
          <p:spPr>
            <a:xfrm>
              <a:off x="5084964" y="1691848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1E31B51D-50F9-4C35-B9A9-E5238A4CF4B6}"/>
                </a:ext>
              </a:extLst>
            </p:cNvPr>
            <p:cNvSpPr txBox="1"/>
            <p:nvPr/>
          </p:nvSpPr>
          <p:spPr>
            <a:xfrm>
              <a:off x="5197952" y="1690819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b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5A511B4-D549-4E6A-BAF1-29C2EA0B8ACC}"/>
                </a:ext>
              </a:extLst>
            </p:cNvPr>
            <p:cNvSpPr txBox="1"/>
            <p:nvPr/>
          </p:nvSpPr>
          <p:spPr>
            <a:xfrm>
              <a:off x="5304059" y="1692085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b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CFCEEA4-680C-4A73-B187-E9D34DF5CFA1}"/>
                </a:ext>
              </a:extLst>
            </p:cNvPr>
            <p:cNvSpPr txBox="1"/>
            <p:nvPr/>
          </p:nvSpPr>
          <p:spPr>
            <a:xfrm>
              <a:off x="5536211" y="1691833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b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9FCA1C2-05BF-47F1-AB1A-BE078EAC62DE}"/>
                </a:ext>
              </a:extLst>
            </p:cNvPr>
            <p:cNvSpPr txBox="1"/>
            <p:nvPr/>
          </p:nvSpPr>
          <p:spPr>
            <a:xfrm>
              <a:off x="4143101" y="1695847"/>
              <a:ext cx="22492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9D6BFA4-1179-44AF-8CEE-A514A870AEA4}"/>
                </a:ext>
              </a:extLst>
            </p:cNvPr>
            <p:cNvSpPr txBox="1"/>
            <p:nvPr/>
          </p:nvSpPr>
          <p:spPr>
            <a:xfrm>
              <a:off x="5427768" y="1690819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b</a:t>
              </a:r>
            </a:p>
          </p:txBody>
        </p: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77D02612-1E30-4940-8CCC-59BB085E7AAD}"/>
                </a:ext>
              </a:extLst>
            </p:cNvPr>
            <p:cNvGrpSpPr/>
            <p:nvPr/>
          </p:nvGrpSpPr>
          <p:grpSpPr>
            <a:xfrm>
              <a:off x="4984041" y="1495816"/>
              <a:ext cx="925308" cy="194925"/>
              <a:chOff x="1833821" y="-618851"/>
              <a:chExt cx="2659161" cy="194925"/>
            </a:xfrm>
          </p:grpSpPr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F2CD4F16-2AD3-4553-9BC8-FE215F78DA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0323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885A3C77-FC0B-4765-8358-744779118216}"/>
                  </a:ext>
                </a:extLst>
              </p:cNvPr>
              <p:cNvSpPr txBox="1"/>
              <p:nvPr/>
            </p:nvSpPr>
            <p:spPr>
              <a:xfrm>
                <a:off x="1833821" y="-618851"/>
                <a:ext cx="2659161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scle bag region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2C2DE9B7-764E-4CEE-B9AE-293E8FB9F4E1}"/>
                </a:ext>
              </a:extLst>
            </p:cNvPr>
            <p:cNvSpPr txBox="1"/>
            <p:nvPr/>
          </p:nvSpPr>
          <p:spPr>
            <a:xfrm>
              <a:off x="3852702" y="2333663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D661238-34D6-4CB5-ACEF-14802E2C25C4}"/>
                </a:ext>
              </a:extLst>
            </p:cNvPr>
            <p:cNvSpPr txBox="1"/>
            <p:nvPr/>
          </p:nvSpPr>
          <p:spPr>
            <a:xfrm>
              <a:off x="3854638" y="2106563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A425E922-EC64-4579-9C84-E126E442DEE8}"/>
                </a:ext>
              </a:extLst>
            </p:cNvPr>
            <p:cNvSpPr txBox="1"/>
            <p:nvPr/>
          </p:nvSpPr>
          <p:spPr>
            <a:xfrm>
              <a:off x="3851754" y="1971966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50bp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92093494-FC73-47F6-92A7-C53096B02EED}"/>
                </a:ext>
              </a:extLst>
            </p:cNvPr>
            <p:cNvSpPr txBox="1"/>
            <p:nvPr/>
          </p:nvSpPr>
          <p:spPr>
            <a:xfrm>
              <a:off x="3873241" y="1884622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41D91577-5A21-4EFA-8FBC-426F256B9C34}"/>
                </a:ext>
              </a:extLst>
            </p:cNvPr>
            <p:cNvSpPr txBox="1"/>
            <p:nvPr/>
          </p:nvSpPr>
          <p:spPr>
            <a:xfrm>
              <a:off x="3873240" y="1844646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4FC715EA-12E5-407A-A093-AA0493E84B7F}"/>
                </a:ext>
              </a:extLst>
            </p:cNvPr>
            <p:cNvGrpSpPr/>
            <p:nvPr/>
          </p:nvGrpSpPr>
          <p:grpSpPr>
            <a:xfrm>
              <a:off x="1032287" y="4151153"/>
              <a:ext cx="715283" cy="203342"/>
              <a:chOff x="2146336" y="-636596"/>
              <a:chExt cx="2055589" cy="203342"/>
            </a:xfrm>
          </p:grpSpPr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68DF673D-836D-4D2C-9E99-6C769F0763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3254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CD114D6C-4F08-4794-85FA-26FFBC8A99A5}"/>
                  </a:ext>
                </a:extLst>
              </p:cNvPr>
              <p:cNvSpPr txBox="1"/>
              <p:nvPr/>
            </p:nvSpPr>
            <p:spPr>
              <a:xfrm>
                <a:off x="2385954" y="-636596"/>
                <a:ext cx="1641938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stine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911FD186-601B-4597-A916-DF2735F81E50}"/>
                </a:ext>
              </a:extLst>
            </p:cNvPr>
            <p:cNvSpPr txBox="1"/>
            <p:nvPr/>
          </p:nvSpPr>
          <p:spPr>
            <a:xfrm>
              <a:off x="963673" y="4363310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55EE01BD-57CF-4DEB-848A-CB1F7D85C01B}"/>
                </a:ext>
              </a:extLst>
            </p:cNvPr>
            <p:cNvSpPr txBox="1"/>
            <p:nvPr/>
          </p:nvSpPr>
          <p:spPr>
            <a:xfrm>
              <a:off x="1069468" y="4363310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i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57642A49-D63E-42AB-B5D8-75F53BB37948}"/>
                </a:ext>
              </a:extLst>
            </p:cNvPr>
            <p:cNvSpPr txBox="1"/>
            <p:nvPr/>
          </p:nvSpPr>
          <p:spPr>
            <a:xfrm>
              <a:off x="1185293" y="4360231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i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4468628-1DC8-41BA-81AE-3701FAC6A73D}"/>
                </a:ext>
              </a:extLst>
            </p:cNvPr>
            <p:cNvSpPr txBox="1"/>
            <p:nvPr/>
          </p:nvSpPr>
          <p:spPr>
            <a:xfrm>
              <a:off x="1273759" y="4361688"/>
              <a:ext cx="279109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i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7566AB2-B3C4-4765-9A54-61036647F3AE}"/>
                </a:ext>
              </a:extLst>
            </p:cNvPr>
            <p:cNvSpPr txBox="1"/>
            <p:nvPr/>
          </p:nvSpPr>
          <p:spPr>
            <a:xfrm>
              <a:off x="1396268" y="4361705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i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8DF54C0-57B0-485D-B8FF-1A1A12C77A0E}"/>
                </a:ext>
              </a:extLst>
            </p:cNvPr>
            <p:cNvSpPr txBox="1"/>
            <p:nvPr/>
          </p:nvSpPr>
          <p:spPr>
            <a:xfrm>
              <a:off x="1506723" y="4361705"/>
              <a:ext cx="243240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i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33176DB1-7863-4E72-BFC8-CB541FA27AD2}"/>
                </a:ext>
              </a:extLst>
            </p:cNvPr>
            <p:cNvSpPr txBox="1"/>
            <p:nvPr/>
          </p:nvSpPr>
          <p:spPr>
            <a:xfrm>
              <a:off x="1597523" y="4362078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C7135C8D-144F-4B83-88E5-E8290DED51D1}"/>
                </a:ext>
              </a:extLst>
            </p:cNvPr>
            <p:cNvSpPr txBox="1"/>
            <p:nvPr/>
          </p:nvSpPr>
          <p:spPr>
            <a:xfrm>
              <a:off x="1711330" y="4358704"/>
              <a:ext cx="26849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</a:t>
              </a:r>
              <a:endPara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1729D671-F10D-426A-AA05-6926B03A1022}"/>
                </a:ext>
              </a:extLst>
            </p:cNvPr>
            <p:cNvSpPr txBox="1"/>
            <p:nvPr/>
          </p:nvSpPr>
          <p:spPr>
            <a:xfrm>
              <a:off x="2376470" y="4360229"/>
              <a:ext cx="271842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AAF95406-FEA1-46C8-A578-9394AA72F100}"/>
                </a:ext>
              </a:extLst>
            </p:cNvPr>
            <p:cNvSpPr txBox="1"/>
            <p:nvPr/>
          </p:nvSpPr>
          <p:spPr>
            <a:xfrm>
              <a:off x="1813998" y="4360620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8D5580F0-EF9E-4815-A8DD-6CC2F1C17BA2}"/>
                </a:ext>
              </a:extLst>
            </p:cNvPr>
            <p:cNvSpPr txBox="1"/>
            <p:nvPr/>
          </p:nvSpPr>
          <p:spPr>
            <a:xfrm>
              <a:off x="1923907" y="4359591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b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E87BD65A-695D-4027-9013-F2368B2EC05D}"/>
                </a:ext>
              </a:extLst>
            </p:cNvPr>
            <p:cNvSpPr txBox="1"/>
            <p:nvPr/>
          </p:nvSpPr>
          <p:spPr>
            <a:xfrm>
              <a:off x="2033093" y="4360857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b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8C0D6A46-3746-4070-8D58-AD998AEB3ED6}"/>
                </a:ext>
              </a:extLst>
            </p:cNvPr>
            <p:cNvSpPr txBox="1"/>
            <p:nvPr/>
          </p:nvSpPr>
          <p:spPr>
            <a:xfrm>
              <a:off x="2265245" y="4360605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b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AE6E45FD-2BB4-45D6-B32E-B6910F9E7BAC}"/>
                </a:ext>
              </a:extLst>
            </p:cNvPr>
            <p:cNvSpPr txBox="1"/>
            <p:nvPr/>
          </p:nvSpPr>
          <p:spPr>
            <a:xfrm>
              <a:off x="865977" y="4361540"/>
              <a:ext cx="22492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40E16B11-3BDA-4841-BC27-3DC463CDDBEB}"/>
                </a:ext>
              </a:extLst>
            </p:cNvPr>
            <p:cNvSpPr txBox="1"/>
            <p:nvPr/>
          </p:nvSpPr>
          <p:spPr>
            <a:xfrm>
              <a:off x="2153723" y="4359591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b</a:t>
              </a:r>
            </a:p>
          </p:txBody>
        </p: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0F5E2057-AE70-4B57-A824-ACDB70BCCF81}"/>
                </a:ext>
              </a:extLst>
            </p:cNvPr>
            <p:cNvGrpSpPr/>
            <p:nvPr/>
          </p:nvGrpSpPr>
          <p:grpSpPr>
            <a:xfrm>
              <a:off x="1710722" y="4152610"/>
              <a:ext cx="925308" cy="200506"/>
              <a:chOff x="1880149" y="-630829"/>
              <a:chExt cx="2659161" cy="200506"/>
            </a:xfrm>
          </p:grpSpPr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D0B1BD9E-62CA-445B-94BA-E20F10AD41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0323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51DD286F-20E7-4FDF-A876-E34FA03BFEDE}"/>
                  </a:ext>
                </a:extLst>
              </p:cNvPr>
              <p:cNvSpPr txBox="1"/>
              <p:nvPr/>
            </p:nvSpPr>
            <p:spPr>
              <a:xfrm>
                <a:off x="1880149" y="-630829"/>
                <a:ext cx="2659161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scle bag region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CF12EC8A-6C7F-459A-8BF8-E4E56B7846C5}"/>
                </a:ext>
              </a:extLst>
            </p:cNvPr>
            <p:cNvSpPr txBox="1"/>
            <p:nvPr/>
          </p:nvSpPr>
          <p:spPr>
            <a:xfrm>
              <a:off x="567339" y="5005623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BD99A44-72B6-4559-95B9-8B9C9D612CC1}"/>
                </a:ext>
              </a:extLst>
            </p:cNvPr>
            <p:cNvSpPr txBox="1"/>
            <p:nvPr/>
          </p:nvSpPr>
          <p:spPr>
            <a:xfrm>
              <a:off x="569275" y="4770878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13537784-9101-4201-8770-D6A1A881DB96}"/>
                </a:ext>
              </a:extLst>
            </p:cNvPr>
            <p:cNvSpPr txBox="1"/>
            <p:nvPr/>
          </p:nvSpPr>
          <p:spPr>
            <a:xfrm>
              <a:off x="566391" y="4648769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50bp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DBFE9B36-2A4D-4DF2-94CA-EBAF536499F3}"/>
                </a:ext>
              </a:extLst>
            </p:cNvPr>
            <p:cNvSpPr txBox="1"/>
            <p:nvPr/>
          </p:nvSpPr>
          <p:spPr>
            <a:xfrm>
              <a:off x="587878" y="4555563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4E8EC9DC-323C-4E85-9C9A-C09A2A2198B2}"/>
                </a:ext>
              </a:extLst>
            </p:cNvPr>
            <p:cNvSpPr txBox="1"/>
            <p:nvPr/>
          </p:nvSpPr>
          <p:spPr>
            <a:xfrm>
              <a:off x="587877" y="4515587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A68A917D-BE9D-4145-A7E0-A645E23D99FB}"/>
                </a:ext>
              </a:extLst>
            </p:cNvPr>
            <p:cNvGrpSpPr/>
            <p:nvPr/>
          </p:nvGrpSpPr>
          <p:grpSpPr>
            <a:xfrm>
              <a:off x="4421361" y="4119190"/>
              <a:ext cx="715283" cy="203342"/>
              <a:chOff x="2022464" y="-636596"/>
              <a:chExt cx="2055589" cy="203342"/>
            </a:xfrm>
          </p:grpSpPr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3A487A9A-6971-47A2-8D06-25B54717F4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22464" y="-433254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666F61D0-D9B1-43C8-B46D-83B8CE839AE1}"/>
                  </a:ext>
                </a:extLst>
              </p:cNvPr>
              <p:cNvSpPr txBox="1"/>
              <p:nvPr/>
            </p:nvSpPr>
            <p:spPr>
              <a:xfrm>
                <a:off x="2226689" y="-636596"/>
                <a:ext cx="1641938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stine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E50A2AFB-5E99-4FD4-A06D-535AE7D65C94}"/>
                </a:ext>
              </a:extLst>
            </p:cNvPr>
            <p:cNvSpPr txBox="1"/>
            <p:nvPr/>
          </p:nvSpPr>
          <p:spPr>
            <a:xfrm>
              <a:off x="4331231" y="4334426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3AD3F9BC-FCA0-4FE5-A48C-4743B54BCA8B}"/>
                </a:ext>
              </a:extLst>
            </p:cNvPr>
            <p:cNvSpPr txBox="1"/>
            <p:nvPr/>
          </p:nvSpPr>
          <p:spPr>
            <a:xfrm>
              <a:off x="4437026" y="4337505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i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BD844D95-EC3D-4E8A-ACA4-C0E662CA355A}"/>
                </a:ext>
              </a:extLst>
            </p:cNvPr>
            <p:cNvSpPr txBox="1"/>
            <p:nvPr/>
          </p:nvSpPr>
          <p:spPr>
            <a:xfrm>
              <a:off x="4549772" y="4334426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i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84EE7CA4-C868-4090-8CED-1826D97AFCF0}"/>
                </a:ext>
              </a:extLst>
            </p:cNvPr>
            <p:cNvSpPr txBox="1"/>
            <p:nvPr/>
          </p:nvSpPr>
          <p:spPr>
            <a:xfrm>
              <a:off x="4635159" y="4335883"/>
              <a:ext cx="279109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i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B7C8B58E-CEFD-4576-AA5C-4955904F6857}"/>
                </a:ext>
              </a:extLst>
            </p:cNvPr>
            <p:cNvSpPr txBox="1"/>
            <p:nvPr/>
          </p:nvSpPr>
          <p:spPr>
            <a:xfrm>
              <a:off x="4766905" y="4338979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i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752E7756-BD35-488D-972B-3C049A4F3B59}"/>
                </a:ext>
              </a:extLst>
            </p:cNvPr>
            <p:cNvSpPr txBox="1"/>
            <p:nvPr/>
          </p:nvSpPr>
          <p:spPr>
            <a:xfrm>
              <a:off x="4871202" y="4338979"/>
              <a:ext cx="243240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i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2CD5A9C0-0483-419F-B6C6-408479970211}"/>
                </a:ext>
              </a:extLst>
            </p:cNvPr>
            <p:cNvSpPr txBox="1"/>
            <p:nvPr/>
          </p:nvSpPr>
          <p:spPr>
            <a:xfrm>
              <a:off x="4962002" y="4336273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903C8B03-EF52-4E28-A1C9-68B938BE1A4F}"/>
                </a:ext>
              </a:extLst>
            </p:cNvPr>
            <p:cNvSpPr txBox="1"/>
            <p:nvPr/>
          </p:nvSpPr>
          <p:spPr>
            <a:xfrm>
              <a:off x="5072730" y="4335978"/>
              <a:ext cx="26849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</a:t>
              </a:r>
              <a:endPara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41DCF366-3B94-40CB-852D-C4437D04CC72}"/>
                </a:ext>
              </a:extLst>
            </p:cNvPr>
            <p:cNvSpPr txBox="1"/>
            <p:nvPr/>
          </p:nvSpPr>
          <p:spPr>
            <a:xfrm>
              <a:off x="5728633" y="4331345"/>
              <a:ext cx="271842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A0F66FA-CEDC-44A0-A408-F7686DD77AD5}"/>
                </a:ext>
              </a:extLst>
            </p:cNvPr>
            <p:cNvSpPr txBox="1"/>
            <p:nvPr/>
          </p:nvSpPr>
          <p:spPr>
            <a:xfrm>
              <a:off x="5172319" y="4337894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F2728075-9C21-4B00-A693-3DF3C5D05F8E}"/>
                </a:ext>
              </a:extLst>
            </p:cNvPr>
            <p:cNvSpPr txBox="1"/>
            <p:nvPr/>
          </p:nvSpPr>
          <p:spPr>
            <a:xfrm>
              <a:off x="5282228" y="4336865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b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2B294754-2E4E-46A0-AE00-56D9DC5A0786}"/>
                </a:ext>
              </a:extLst>
            </p:cNvPr>
            <p:cNvSpPr txBox="1"/>
            <p:nvPr/>
          </p:nvSpPr>
          <p:spPr>
            <a:xfrm>
              <a:off x="5388335" y="4335052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b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0BC4CAEB-F95F-44B3-BB05-6C772DFFF150}"/>
                </a:ext>
              </a:extLst>
            </p:cNvPr>
            <p:cNvSpPr txBox="1"/>
            <p:nvPr/>
          </p:nvSpPr>
          <p:spPr>
            <a:xfrm>
              <a:off x="5620487" y="4334800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b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C94BAC9C-DE76-4921-A15D-7E343F5A273D}"/>
                </a:ext>
              </a:extLst>
            </p:cNvPr>
            <p:cNvSpPr txBox="1"/>
            <p:nvPr/>
          </p:nvSpPr>
          <p:spPr>
            <a:xfrm>
              <a:off x="4236451" y="4335991"/>
              <a:ext cx="22492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402696AF-411E-49ED-B4BB-E9416C45FAE7}"/>
                </a:ext>
              </a:extLst>
            </p:cNvPr>
            <p:cNvSpPr txBox="1"/>
            <p:nvPr/>
          </p:nvSpPr>
          <p:spPr>
            <a:xfrm>
              <a:off x="5508965" y="4333786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b</a:t>
              </a:r>
            </a:p>
          </p:txBody>
        </p: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F54027D6-C0AF-4ECB-AB1C-7B4236EBAD40}"/>
                </a:ext>
              </a:extLst>
            </p:cNvPr>
            <p:cNvGrpSpPr/>
            <p:nvPr/>
          </p:nvGrpSpPr>
          <p:grpSpPr>
            <a:xfrm>
              <a:off x="5084401" y="4120647"/>
              <a:ext cx="925308" cy="200506"/>
              <a:chOff x="1712035" y="-630829"/>
              <a:chExt cx="2659161" cy="200506"/>
            </a:xfrm>
          </p:grpSpPr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id="{CC82F6FD-DE9B-46B9-BC20-74F7966DF4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78221" y="-430323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9F0A655B-54D5-43D6-86EF-F7A0A4824336}"/>
                  </a:ext>
                </a:extLst>
              </p:cNvPr>
              <p:cNvSpPr txBox="1"/>
              <p:nvPr/>
            </p:nvSpPr>
            <p:spPr>
              <a:xfrm>
                <a:off x="1712035" y="-630829"/>
                <a:ext cx="2659161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scle bag region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B1D64137-279C-4409-86FC-B2F9DB120DDA}"/>
                </a:ext>
              </a:extLst>
            </p:cNvPr>
            <p:cNvSpPr txBox="1"/>
            <p:nvPr/>
          </p:nvSpPr>
          <p:spPr>
            <a:xfrm>
              <a:off x="3945365" y="4932626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4EC3E1DF-69C1-4D17-8482-7AB27F93AB16}"/>
                </a:ext>
              </a:extLst>
            </p:cNvPr>
            <p:cNvSpPr txBox="1"/>
            <p:nvPr/>
          </p:nvSpPr>
          <p:spPr>
            <a:xfrm>
              <a:off x="3947301" y="4706292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594AA05D-9203-4F8E-94F7-21FBF6B14539}"/>
                </a:ext>
              </a:extLst>
            </p:cNvPr>
            <p:cNvSpPr txBox="1"/>
            <p:nvPr/>
          </p:nvSpPr>
          <p:spPr>
            <a:xfrm>
              <a:off x="3944417" y="4596289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50bp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288C770-14DA-48DD-9A3C-FE66F469602D}"/>
                </a:ext>
              </a:extLst>
            </p:cNvPr>
            <p:cNvSpPr txBox="1"/>
            <p:nvPr/>
          </p:nvSpPr>
          <p:spPr>
            <a:xfrm>
              <a:off x="3955965" y="4528441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E6404475-9B0F-4557-AF7B-098BF1493F1D}"/>
                </a:ext>
              </a:extLst>
            </p:cNvPr>
            <p:cNvSpPr txBox="1"/>
            <p:nvPr/>
          </p:nvSpPr>
          <p:spPr>
            <a:xfrm>
              <a:off x="3955964" y="4495091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E049D56A-8652-4F33-8F68-60B281DDD2E5}"/>
                </a:ext>
              </a:extLst>
            </p:cNvPr>
            <p:cNvGrpSpPr/>
            <p:nvPr/>
          </p:nvGrpSpPr>
          <p:grpSpPr>
            <a:xfrm>
              <a:off x="1021390" y="6897209"/>
              <a:ext cx="715283" cy="203342"/>
              <a:chOff x="2146336" y="-636596"/>
              <a:chExt cx="2055589" cy="203342"/>
            </a:xfrm>
          </p:grpSpPr>
          <p:cxnSp>
            <p:nvCxnSpPr>
              <p:cNvPr id="130" name="Straight Connector 129">
                <a:extLst>
                  <a:ext uri="{FF2B5EF4-FFF2-40B4-BE49-F238E27FC236}">
                    <a16:creationId xmlns:a16="http://schemas.microsoft.com/office/drawing/2014/main" id="{E23EFF64-8872-4B8F-961E-FBEE7532EF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3254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F970B89D-6A76-416B-ADAB-4A8F758534F1}"/>
                  </a:ext>
                </a:extLst>
              </p:cNvPr>
              <p:cNvSpPr txBox="1"/>
              <p:nvPr/>
            </p:nvSpPr>
            <p:spPr>
              <a:xfrm>
                <a:off x="2350561" y="-636596"/>
                <a:ext cx="1641938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stine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0F3F81EF-22FB-46B3-87DF-E065D5CBF200}"/>
                </a:ext>
              </a:extLst>
            </p:cNvPr>
            <p:cNvSpPr txBox="1"/>
            <p:nvPr/>
          </p:nvSpPr>
          <p:spPr>
            <a:xfrm>
              <a:off x="934302" y="7112445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E36231CC-426A-4296-88A1-971D3A5B3DDF}"/>
                </a:ext>
              </a:extLst>
            </p:cNvPr>
            <p:cNvSpPr txBox="1"/>
            <p:nvPr/>
          </p:nvSpPr>
          <p:spPr>
            <a:xfrm>
              <a:off x="1037018" y="7112445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i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478FBBA1-0F61-404A-9C42-F1BE1A933227}"/>
                </a:ext>
              </a:extLst>
            </p:cNvPr>
            <p:cNvSpPr txBox="1"/>
            <p:nvPr/>
          </p:nvSpPr>
          <p:spPr>
            <a:xfrm>
              <a:off x="1152843" y="7112445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i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20DE663D-2AB8-4977-9DC6-2346C6C6DB19}"/>
                </a:ext>
              </a:extLst>
            </p:cNvPr>
            <p:cNvSpPr txBox="1"/>
            <p:nvPr/>
          </p:nvSpPr>
          <p:spPr>
            <a:xfrm>
              <a:off x="1238230" y="7110823"/>
              <a:ext cx="279109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i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60848ECD-8B12-47C9-AC40-56B0AEF4A91D}"/>
                </a:ext>
              </a:extLst>
            </p:cNvPr>
            <p:cNvSpPr txBox="1"/>
            <p:nvPr/>
          </p:nvSpPr>
          <p:spPr>
            <a:xfrm>
              <a:off x="1366897" y="7107761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i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F6A77FB5-92EF-46DE-8A95-37C3EC33E293}"/>
                </a:ext>
              </a:extLst>
            </p:cNvPr>
            <p:cNvSpPr txBox="1"/>
            <p:nvPr/>
          </p:nvSpPr>
          <p:spPr>
            <a:xfrm>
              <a:off x="1480431" y="7107761"/>
              <a:ext cx="243240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i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5A5A8C4F-434F-4AC6-812B-B1DC934A9163}"/>
                </a:ext>
              </a:extLst>
            </p:cNvPr>
            <p:cNvSpPr txBox="1"/>
            <p:nvPr/>
          </p:nvSpPr>
          <p:spPr>
            <a:xfrm>
              <a:off x="1568152" y="7108134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F9B4EFE3-5EF4-4D2B-85DD-B891E708FFB6}"/>
                </a:ext>
              </a:extLst>
            </p:cNvPr>
            <p:cNvSpPr txBox="1"/>
            <p:nvPr/>
          </p:nvSpPr>
          <p:spPr>
            <a:xfrm>
              <a:off x="1678880" y="7104760"/>
              <a:ext cx="26849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</a:t>
              </a:r>
              <a:endPara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26119268-163B-43A3-AE75-9852BFB2E4C9}"/>
                </a:ext>
              </a:extLst>
            </p:cNvPr>
            <p:cNvSpPr txBox="1"/>
            <p:nvPr/>
          </p:nvSpPr>
          <p:spPr>
            <a:xfrm>
              <a:off x="2340941" y="7106285"/>
              <a:ext cx="271842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9DCE6DB0-E020-4839-BCCF-87906D4C30A7}"/>
                </a:ext>
              </a:extLst>
            </p:cNvPr>
            <p:cNvSpPr txBox="1"/>
            <p:nvPr/>
          </p:nvSpPr>
          <p:spPr>
            <a:xfrm>
              <a:off x="1784627" y="7106676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A2F34A16-F835-4774-936B-8DE71332961B}"/>
                </a:ext>
              </a:extLst>
            </p:cNvPr>
            <p:cNvSpPr txBox="1"/>
            <p:nvPr/>
          </p:nvSpPr>
          <p:spPr>
            <a:xfrm>
              <a:off x="1897615" y="7105647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b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8AD51D11-EA1B-4C28-813F-C454A291447D}"/>
                </a:ext>
              </a:extLst>
            </p:cNvPr>
            <p:cNvSpPr txBox="1"/>
            <p:nvPr/>
          </p:nvSpPr>
          <p:spPr>
            <a:xfrm>
              <a:off x="1997564" y="7103834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b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FA308544-F3B7-4D2E-9064-DEEB64972C45}"/>
                </a:ext>
              </a:extLst>
            </p:cNvPr>
            <p:cNvSpPr txBox="1"/>
            <p:nvPr/>
          </p:nvSpPr>
          <p:spPr>
            <a:xfrm>
              <a:off x="2229716" y="7103582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b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F597D9A2-D75B-4366-996B-1FA6382AF29C}"/>
                </a:ext>
              </a:extLst>
            </p:cNvPr>
            <p:cNvSpPr txBox="1"/>
            <p:nvPr/>
          </p:nvSpPr>
          <p:spPr>
            <a:xfrm>
              <a:off x="836606" y="7113754"/>
              <a:ext cx="22492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173DD4E4-A7A7-4B9D-BD10-7E442D0655A6}"/>
                </a:ext>
              </a:extLst>
            </p:cNvPr>
            <p:cNvSpPr txBox="1"/>
            <p:nvPr/>
          </p:nvSpPr>
          <p:spPr>
            <a:xfrm>
              <a:off x="2124352" y="7105647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b</a:t>
              </a:r>
            </a:p>
          </p:txBody>
        </p: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C3AD1A9E-BFC5-4ECD-A92D-1206E0B14DEB}"/>
                </a:ext>
              </a:extLst>
            </p:cNvPr>
            <p:cNvGrpSpPr/>
            <p:nvPr/>
          </p:nvGrpSpPr>
          <p:grpSpPr>
            <a:xfrm>
              <a:off x="1699825" y="6898666"/>
              <a:ext cx="925308" cy="200506"/>
              <a:chOff x="1880149" y="-630829"/>
              <a:chExt cx="2659161" cy="200506"/>
            </a:xfrm>
          </p:grpSpPr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id="{B6F099F4-CDCE-4317-ACEB-14A524048C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0323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A4A3D19C-02B5-496C-824B-B53887420FD3}"/>
                  </a:ext>
                </a:extLst>
              </p:cNvPr>
              <p:cNvSpPr txBox="1"/>
              <p:nvPr/>
            </p:nvSpPr>
            <p:spPr>
              <a:xfrm>
                <a:off x="1880149" y="-630829"/>
                <a:ext cx="2659161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scle bag region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20E1E863-2BF9-435A-B63A-0F9C3530FB12}"/>
                </a:ext>
              </a:extLst>
            </p:cNvPr>
            <p:cNvSpPr txBox="1"/>
            <p:nvPr/>
          </p:nvSpPr>
          <p:spPr>
            <a:xfrm>
              <a:off x="546503" y="7767733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5A9794DB-083D-4140-9A09-45C72EEBAC5B}"/>
                </a:ext>
              </a:extLst>
            </p:cNvPr>
            <p:cNvSpPr txBox="1"/>
            <p:nvPr/>
          </p:nvSpPr>
          <p:spPr>
            <a:xfrm>
              <a:off x="548439" y="7521777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D834D0E1-CC43-42AD-AF20-7457CCB13CF4}"/>
                </a:ext>
              </a:extLst>
            </p:cNvPr>
            <p:cNvSpPr txBox="1"/>
            <p:nvPr/>
          </p:nvSpPr>
          <p:spPr>
            <a:xfrm>
              <a:off x="545555" y="7393299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50bp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5F20B2A4-B923-4982-871F-EDD8C3B71E16}"/>
                </a:ext>
              </a:extLst>
            </p:cNvPr>
            <p:cNvSpPr txBox="1"/>
            <p:nvPr/>
          </p:nvSpPr>
          <p:spPr>
            <a:xfrm>
              <a:off x="567042" y="7298440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EF2A7528-E2C2-46CC-A388-7C66EE2AAD2F}"/>
                </a:ext>
              </a:extLst>
            </p:cNvPr>
            <p:cNvSpPr txBox="1"/>
            <p:nvPr/>
          </p:nvSpPr>
          <p:spPr>
            <a:xfrm>
              <a:off x="567041" y="7258464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5" name="Group 174">
              <a:extLst>
                <a:ext uri="{FF2B5EF4-FFF2-40B4-BE49-F238E27FC236}">
                  <a16:creationId xmlns:a16="http://schemas.microsoft.com/office/drawing/2014/main" id="{45876CBD-4379-4B00-BD84-98C9981C1B48}"/>
                </a:ext>
              </a:extLst>
            </p:cNvPr>
            <p:cNvGrpSpPr/>
            <p:nvPr/>
          </p:nvGrpSpPr>
          <p:grpSpPr>
            <a:xfrm>
              <a:off x="4449588" y="6771373"/>
              <a:ext cx="715283" cy="203342"/>
              <a:chOff x="2146336" y="-636596"/>
              <a:chExt cx="2055589" cy="203342"/>
            </a:xfrm>
          </p:grpSpPr>
          <p:cxnSp>
            <p:nvCxnSpPr>
              <p:cNvPr id="176" name="Straight Connector 175">
                <a:extLst>
                  <a:ext uri="{FF2B5EF4-FFF2-40B4-BE49-F238E27FC236}">
                    <a16:creationId xmlns:a16="http://schemas.microsoft.com/office/drawing/2014/main" id="{D4F49C66-3612-4AA0-9B3D-BA1B467579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3254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D0E8CD40-DD21-4B57-835C-A76150B47D14}"/>
                  </a:ext>
                </a:extLst>
              </p:cNvPr>
              <p:cNvSpPr txBox="1"/>
              <p:nvPr/>
            </p:nvSpPr>
            <p:spPr>
              <a:xfrm>
                <a:off x="2350561" y="-636596"/>
                <a:ext cx="1641938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stine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976E5E19-98FB-480F-A7EF-7C3518ACBDA4}"/>
                </a:ext>
              </a:extLst>
            </p:cNvPr>
            <p:cNvSpPr txBox="1"/>
            <p:nvPr/>
          </p:nvSpPr>
          <p:spPr>
            <a:xfrm>
              <a:off x="4368658" y="6980451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0AFB0497-56FE-450A-987A-2CDE89C9B5BB}"/>
                </a:ext>
              </a:extLst>
            </p:cNvPr>
            <p:cNvSpPr txBox="1"/>
            <p:nvPr/>
          </p:nvSpPr>
          <p:spPr>
            <a:xfrm>
              <a:off x="4474453" y="6980451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i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8E5F07AF-3677-405A-8C3E-44CCC7A53B42}"/>
                </a:ext>
              </a:extLst>
            </p:cNvPr>
            <p:cNvSpPr txBox="1"/>
            <p:nvPr/>
          </p:nvSpPr>
          <p:spPr>
            <a:xfrm>
              <a:off x="4587199" y="6980451"/>
              <a:ext cx="238103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i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4A0DF260-080F-44AD-BAB5-7DFF20936774}"/>
                </a:ext>
              </a:extLst>
            </p:cNvPr>
            <p:cNvSpPr txBox="1"/>
            <p:nvPr/>
          </p:nvSpPr>
          <p:spPr>
            <a:xfrm>
              <a:off x="4675665" y="6981908"/>
              <a:ext cx="279109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i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2D0167B4-6817-421B-B40E-0D07DB8B63F8}"/>
                </a:ext>
              </a:extLst>
            </p:cNvPr>
            <p:cNvSpPr txBox="1"/>
            <p:nvPr/>
          </p:nvSpPr>
          <p:spPr>
            <a:xfrm>
              <a:off x="4801253" y="6981925"/>
              <a:ext cx="24214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i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2C36C1BB-2BD3-42CF-B567-A7E3A3071A4C}"/>
                </a:ext>
              </a:extLst>
            </p:cNvPr>
            <p:cNvSpPr txBox="1"/>
            <p:nvPr/>
          </p:nvSpPr>
          <p:spPr>
            <a:xfrm>
              <a:off x="4908629" y="6981925"/>
              <a:ext cx="243240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i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8BBC7C3F-EB66-4FAB-92A8-498722A72C62}"/>
                </a:ext>
              </a:extLst>
            </p:cNvPr>
            <p:cNvSpPr txBox="1"/>
            <p:nvPr/>
          </p:nvSpPr>
          <p:spPr>
            <a:xfrm>
              <a:off x="4996350" y="6982298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F1EB63CC-6A1F-4366-950D-325789B9E66D}"/>
                </a:ext>
              </a:extLst>
            </p:cNvPr>
            <p:cNvSpPr txBox="1"/>
            <p:nvPr/>
          </p:nvSpPr>
          <p:spPr>
            <a:xfrm>
              <a:off x="5110157" y="6982003"/>
              <a:ext cx="26849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</a:t>
              </a:r>
              <a:endPara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8588A5DD-1DE8-42C5-9683-698AE63E69F0}"/>
                </a:ext>
              </a:extLst>
            </p:cNvPr>
            <p:cNvSpPr txBox="1"/>
            <p:nvPr/>
          </p:nvSpPr>
          <p:spPr>
            <a:xfrm>
              <a:off x="5766060" y="6983528"/>
              <a:ext cx="271842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6A999785-6137-4190-BB5C-A8070133EE0C}"/>
                </a:ext>
              </a:extLst>
            </p:cNvPr>
            <p:cNvSpPr txBox="1"/>
            <p:nvPr/>
          </p:nvSpPr>
          <p:spPr>
            <a:xfrm>
              <a:off x="5206667" y="6983919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14CA9AC5-29A6-4E33-8192-CE5BB7DC4B70}"/>
                </a:ext>
              </a:extLst>
            </p:cNvPr>
            <p:cNvSpPr txBox="1"/>
            <p:nvPr/>
          </p:nvSpPr>
          <p:spPr>
            <a:xfrm>
              <a:off x="5319655" y="6982890"/>
              <a:ext cx="282384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b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4AC37F45-16A4-4912-8ECD-1D27283D13AC}"/>
                </a:ext>
              </a:extLst>
            </p:cNvPr>
            <p:cNvSpPr txBox="1"/>
            <p:nvPr/>
          </p:nvSpPr>
          <p:spPr>
            <a:xfrm>
              <a:off x="5428841" y="6981077"/>
              <a:ext cx="28238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b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5CA5AC22-8F7E-45BA-B5E5-F67BDB505EE5}"/>
                </a:ext>
              </a:extLst>
            </p:cNvPr>
            <p:cNvSpPr txBox="1"/>
            <p:nvPr/>
          </p:nvSpPr>
          <p:spPr>
            <a:xfrm>
              <a:off x="5657914" y="6980825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b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8E1CC75C-8429-482B-ACBE-25FB3CF29CF1}"/>
                </a:ext>
              </a:extLst>
            </p:cNvPr>
            <p:cNvSpPr txBox="1"/>
            <p:nvPr/>
          </p:nvSpPr>
          <p:spPr>
            <a:xfrm>
              <a:off x="4270964" y="6978681"/>
              <a:ext cx="224925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AA00A16F-66E7-4D2C-A002-0FF504918D94}"/>
                </a:ext>
              </a:extLst>
            </p:cNvPr>
            <p:cNvSpPr txBox="1"/>
            <p:nvPr/>
          </p:nvSpPr>
          <p:spPr>
            <a:xfrm>
              <a:off x="5549471" y="6982890"/>
              <a:ext cx="258051" cy="16414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b</a:t>
              </a:r>
            </a:p>
          </p:txBody>
        </p:sp>
        <p:grpSp>
          <p:nvGrpSpPr>
            <p:cNvPr id="193" name="Group 192">
              <a:extLst>
                <a:ext uri="{FF2B5EF4-FFF2-40B4-BE49-F238E27FC236}">
                  <a16:creationId xmlns:a16="http://schemas.microsoft.com/office/drawing/2014/main" id="{1344F79D-68D7-43D6-8F96-5291686743F6}"/>
                </a:ext>
              </a:extLst>
            </p:cNvPr>
            <p:cNvGrpSpPr/>
            <p:nvPr/>
          </p:nvGrpSpPr>
          <p:grpSpPr>
            <a:xfrm>
              <a:off x="5128023" y="6772830"/>
              <a:ext cx="925308" cy="200506"/>
              <a:chOff x="1880149" y="-630829"/>
              <a:chExt cx="2659161" cy="200506"/>
            </a:xfrm>
          </p:grpSpPr>
          <p:cxnSp>
            <p:nvCxnSpPr>
              <p:cNvPr id="194" name="Straight Connector 193">
                <a:extLst>
                  <a:ext uri="{FF2B5EF4-FFF2-40B4-BE49-F238E27FC236}">
                    <a16:creationId xmlns:a16="http://schemas.microsoft.com/office/drawing/2014/main" id="{5A2006B6-5E27-4147-8924-E6C4C8B0A3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46336" y="-430323"/>
                <a:ext cx="205558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4B7B39BE-D909-4759-B9D5-8001E0E9F1DB}"/>
                  </a:ext>
                </a:extLst>
              </p:cNvPr>
              <p:cNvSpPr txBox="1"/>
              <p:nvPr/>
            </p:nvSpPr>
            <p:spPr>
              <a:xfrm>
                <a:off x="1880149" y="-630829"/>
                <a:ext cx="2659161" cy="19492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scle bag region</a:t>
                </a:r>
                <a:endParaRPr lang="en-US" sz="11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A32EE69D-D753-42EF-AE1A-4AD0C0650FE5}"/>
                </a:ext>
              </a:extLst>
            </p:cNvPr>
            <p:cNvSpPr txBox="1"/>
            <p:nvPr/>
          </p:nvSpPr>
          <p:spPr>
            <a:xfrm>
              <a:off x="3969700" y="7518464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E3F32453-0BB7-47BB-B45F-30F530D26CB1}"/>
                </a:ext>
              </a:extLst>
            </p:cNvPr>
            <p:cNvSpPr txBox="1"/>
            <p:nvPr/>
          </p:nvSpPr>
          <p:spPr>
            <a:xfrm>
              <a:off x="3971636" y="7311243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E2D027CA-52AD-4EC9-BC64-4E63144E677C}"/>
                </a:ext>
              </a:extLst>
            </p:cNvPr>
            <p:cNvSpPr txBox="1"/>
            <p:nvPr/>
          </p:nvSpPr>
          <p:spPr>
            <a:xfrm>
              <a:off x="3968752" y="7207102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50bp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1471891B-D007-4645-9574-B9F242002378}"/>
                </a:ext>
              </a:extLst>
            </p:cNvPr>
            <p:cNvSpPr txBox="1"/>
            <p:nvPr/>
          </p:nvSpPr>
          <p:spPr>
            <a:xfrm>
              <a:off x="3990239" y="7156076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894FC49C-9104-4342-BD54-70E2D3426736}"/>
                </a:ext>
              </a:extLst>
            </p:cNvPr>
            <p:cNvSpPr txBox="1"/>
            <p:nvPr/>
          </p:nvSpPr>
          <p:spPr>
            <a:xfrm>
              <a:off x="3990238" y="7116100"/>
              <a:ext cx="592041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3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F76BCC2B-50DB-45C6-AEAF-4AE46082D535}"/>
                </a:ext>
              </a:extLst>
            </p:cNvPr>
            <p:cNvSpPr txBox="1"/>
            <p:nvPr/>
          </p:nvSpPr>
          <p:spPr>
            <a:xfrm>
              <a:off x="1030917" y="3989489"/>
              <a:ext cx="1495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u-trp-2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589D2D6D-9243-4398-9623-B314DF912EEC}"/>
                </a:ext>
              </a:extLst>
            </p:cNvPr>
            <p:cNvSpPr txBox="1"/>
            <p:nvPr/>
          </p:nvSpPr>
          <p:spPr>
            <a:xfrm>
              <a:off x="4376944" y="3962227"/>
              <a:ext cx="1495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u-ocr-1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2CC3D771-B606-4BCC-A7B1-F4035AA38854}"/>
                </a:ext>
              </a:extLst>
            </p:cNvPr>
            <p:cNvSpPr txBox="1"/>
            <p:nvPr/>
          </p:nvSpPr>
          <p:spPr>
            <a:xfrm>
              <a:off x="928839" y="1372219"/>
              <a:ext cx="1495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u-gon-2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2542AE83-8CCF-4278-B5EF-9D711088DAC9}"/>
                </a:ext>
              </a:extLst>
            </p:cNvPr>
            <p:cNvSpPr txBox="1"/>
            <p:nvPr/>
          </p:nvSpPr>
          <p:spPr>
            <a:xfrm>
              <a:off x="4322843" y="1375792"/>
              <a:ext cx="1495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u-ced-11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72011362-982E-455C-BC5A-6B398B97DF05}"/>
                </a:ext>
              </a:extLst>
            </p:cNvPr>
            <p:cNvSpPr txBox="1"/>
            <p:nvPr/>
          </p:nvSpPr>
          <p:spPr>
            <a:xfrm>
              <a:off x="1018290" y="6759157"/>
              <a:ext cx="1495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u-osm-9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14594AC2-7CB7-4EE4-BEAF-2DC0B834C488}"/>
                </a:ext>
              </a:extLst>
            </p:cNvPr>
            <p:cNvSpPr txBox="1"/>
            <p:nvPr/>
          </p:nvSpPr>
          <p:spPr>
            <a:xfrm>
              <a:off x="4443795" y="6630246"/>
              <a:ext cx="1495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u-trpa-1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64C39AA8-955E-4130-AC9B-1075529F1CF1}"/>
              </a:ext>
            </a:extLst>
          </p:cNvPr>
          <p:cNvSpPr txBox="1"/>
          <p:nvPr/>
        </p:nvSpPr>
        <p:spPr>
          <a:xfrm>
            <a:off x="112110" y="8395063"/>
            <a:ext cx="6623420" cy="17234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Localization of TRP channels in the intestine and muscle bag region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iginal uncropped gel pictures from Fig. 2 showing RT-PCR analysis of intestine (1i, 2i, 3i, 4i, 5i) and muscle bag (1b, 2b, 3b, 4b, 5b) of five separate female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suum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orms. Each lane represents the intestine or muscle bag of an individual worm.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gapdh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rom the intestine (Ci) or muscle bag (Cb) was used as a positive control. N.C. = negative control, no cDNA template present. M =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stRuler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ddle Range DNA Ladder (ThermoFisher Scientific). A)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gon-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B)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ced-11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)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trp-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D)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ocr-1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)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osm-9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F)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trpa-1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mages were taken under UV light with an exposure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tting of 3 seconds per 1 frame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1935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35</TotalTime>
  <Words>328</Words>
  <Application>Microsoft Office PowerPoint</Application>
  <PresentationFormat>A4 Paper (210x297 mm)</PresentationFormat>
  <Paragraphs>1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Custom Desig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Williams</dc:creator>
  <cp:lastModifiedBy>martinlab</cp:lastModifiedBy>
  <cp:revision>132</cp:revision>
  <dcterms:created xsi:type="dcterms:W3CDTF">2020-10-13T16:20:28Z</dcterms:created>
  <dcterms:modified xsi:type="dcterms:W3CDTF">2022-08-12T17:55:17Z</dcterms:modified>
</cp:coreProperties>
</file>